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29F8CA6-1A19-483A-A24D-6DEFE07C78D5}" v="2" dt="2022-12-03T02:09:52.22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>
      <p:cViewPr varScale="1">
        <p:scale>
          <a:sx n="88" d="100"/>
          <a:sy n="88" d="100"/>
        </p:scale>
        <p:origin x="96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F47456-7CFA-4DCC-9592-032B068BFA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FF6B95C-8C1F-48FD-A1A9-9C2020E83C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E32CFC-0A07-42B6-BEDE-EB50D4646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7908B1-4BC0-4820-9BDF-D6FBC9602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5C4DCE-395C-49FE-8198-FDDA938F6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1020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C70654-2F6E-4929-8D32-DC09191115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F288CE2-50C4-45F5-830A-381B07BEF5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1B4B7D-D3CF-496D-A1BE-5D66D8D92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905D43-071D-4359-B4DE-3E0F12E9C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0AA1B4-03A2-4F5A-8507-1BBE8E32B4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02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BC67F7A-599D-4C0E-86FB-911F6698B2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92605F0-D08D-478E-8601-66E6F9AD1C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7064B4-3759-4E3F-BCBA-6261F0DDD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8BDE90-A8A8-4CD2-99F2-FF2B40DA7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31CAF6-4533-456A-A7D6-D3D504E28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8641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364548-DEF6-4961-B5CE-AB5055710B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529DB35-5F16-4780-B7D3-BF99CB3600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5CFE9E-C01F-4E56-87D8-B97137A21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09F40D-FC59-4D75-86E4-C7F898182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4A390E-59CE-4508-99EF-98DE201F9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4561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4182E1-D0EF-4097-9808-36929E34F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24B1281-1086-4505-8944-D1315883A3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42BDA6-81D3-43AC-A84B-21D4B29C7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CD3C3D-AA80-47A6-A5A1-FF9E10D50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6F9748-4882-4BD2-A2D5-BD97BA9B1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538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42FCAB-19C8-4B35-B8F1-39BC994925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FBBB7E5-4467-4901-B535-1B33694E5B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69B1FF4-7845-435A-96BA-80A6F13CD5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A8DC5B-2573-4D91-9CB9-09435DF2D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243AB5-124B-4C18-A9F8-485EA15F1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7E9A85-D50C-4FD2-9853-EF7B42BE4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25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711E7D-2FA3-4964-AADE-67E97E62E4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1BFA7CD-6399-4F46-9BE2-AC3D456CA8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D86C82F-80F6-4C65-9FD0-29C2064039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D2D0752-DA2D-4F26-948A-70ED590717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ED25790-4082-4555-8FB9-7134085B9E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2B371D3-B574-44C9-8CF8-35AEC4522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05FE63C-2557-4EFC-9A81-FF2BE8207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B930CC4-D4A6-44A9-8717-6BA5348E8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669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B0F622-1D49-4D7B-B3DF-95991CD93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411287D-4525-4265-921B-F178B9BBE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CA69C48-3F43-4135-80DC-8C074C45F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23942D8-B8CA-439F-B9CB-EA1710B92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641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81E52CA-13D2-4268-9571-5CDF8B22C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4CBAB73-E571-4EB8-881F-625C30415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AC72ACD-A1AF-4FEC-8016-201642A02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9045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9CC2BD-A906-4A5E-ADEA-E7B0624A70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74EB3CA-B6A8-47E8-83B8-9715847B95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6A11DD3-90FB-4B45-A0C7-0D8728B9E3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71D711-DB4D-425A-AB81-B9C2DAE5D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30A1C1-F058-4B0A-81F7-4E51037CE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E27FE5F-4E2F-449A-92EE-AE3111F03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42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04311E-DD79-4A79-9ABB-2AB57950B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02F5A9B-8839-4041-A25F-94354F7E5F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7E274E7-4973-42F8-AAEF-F8E4824DA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1169A09-11B8-483B-BE38-51187B762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FD07BA-B5CB-4983-97E2-1948AF278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3AC73F2-C9AB-4848-BFAF-88367BAB0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5290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86E0A26-A3A3-449B-9189-79F5886C3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91CCFB-A3A3-488D-AE1D-3B2A4FB5BE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06B684-8D92-432D-B440-7A4237CE9D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5C598-15BC-40BF-B550-C299236B1CC2}" type="datetimeFigureOut">
              <a:rPr kumimoji="1" lang="ja-JP" altLang="en-US" smtClean="0"/>
              <a:t>2023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31D6F8-D9B9-4F52-AFA9-8EE8AAA870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2F420C-DE81-4BC7-BE30-239C73696C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87FA5B-219C-42C8-AA47-9F24A6E627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471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7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tiff"/><Relationship Id="rId5" Type="http://schemas.microsoft.com/office/2007/relationships/hdphoto" Target="../media/hdphoto2.wdp"/><Relationship Id="rId15" Type="http://schemas.openxmlformats.org/officeDocument/2006/relationships/image" Target="../media/image9.wmf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5.png"/><Relationship Id="rId7" Type="http://schemas.openxmlformats.org/officeDocument/2006/relationships/image" Target="../media/image11.tif"/><Relationship Id="rId12" Type="http://schemas.openxmlformats.org/officeDocument/2006/relationships/image" Target="../media/image9.wm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f"/><Relationship Id="rId11" Type="http://schemas.openxmlformats.org/officeDocument/2006/relationships/oleObject" Target="../embeddings/oleObject2.bin"/><Relationship Id="rId5" Type="http://schemas.openxmlformats.org/officeDocument/2006/relationships/image" Target="../media/image7.tiff"/><Relationship Id="rId10" Type="http://schemas.openxmlformats.org/officeDocument/2006/relationships/image" Target="../media/image13.tif"/><Relationship Id="rId4" Type="http://schemas.openxmlformats.org/officeDocument/2006/relationships/image" Target="../media/image6.tiff"/><Relationship Id="rId9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 descr="屋外, 草, フィールド, 写真 が含まれている画像&#10;&#10;自動的に生成された説明">
            <a:extLst>
              <a:ext uri="{FF2B5EF4-FFF2-40B4-BE49-F238E27FC236}">
                <a16:creationId xmlns:a16="http://schemas.microsoft.com/office/drawing/2014/main" id="{D0EFAF85-B79E-F6B3-BF81-04180651EB5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7494"/>
          <a:stretch/>
        </p:blipFill>
        <p:spPr>
          <a:xfrm>
            <a:off x="2992338" y="2337821"/>
            <a:ext cx="2310598" cy="1603080"/>
          </a:xfrm>
          <a:prstGeom prst="rect">
            <a:avLst/>
          </a:prstGeom>
        </p:spPr>
      </p:pic>
      <p:pic>
        <p:nvPicPr>
          <p:cNvPr id="7" name="図 6" descr="白黒の写真&#10;&#10;低い精度で自動的に生成された説明">
            <a:extLst>
              <a:ext uri="{FF2B5EF4-FFF2-40B4-BE49-F238E27FC236}">
                <a16:creationId xmlns:a16="http://schemas.microsoft.com/office/drawing/2014/main" id="{3E78CF8F-95EA-E954-034C-DBE8B6A70AF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8178"/>
          <a:stretch/>
        </p:blipFill>
        <p:spPr>
          <a:xfrm>
            <a:off x="606795" y="2337820"/>
            <a:ext cx="2327810" cy="1603080"/>
          </a:xfrm>
          <a:prstGeom prst="rect">
            <a:avLst/>
          </a:prstGeom>
        </p:spPr>
      </p:pic>
      <p:pic>
        <p:nvPicPr>
          <p:cNvPr id="3" name="図 2" descr="白黒の写真&#10;&#10;低い精度で自動的に生成された説明">
            <a:extLst>
              <a:ext uri="{FF2B5EF4-FFF2-40B4-BE49-F238E27FC236}">
                <a16:creationId xmlns:a16="http://schemas.microsoft.com/office/drawing/2014/main" id="{527EAD10-895C-A6B0-6909-824F35DC9F9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r="49999" b="53694"/>
          <a:stretch/>
        </p:blipFill>
        <p:spPr>
          <a:xfrm>
            <a:off x="602309" y="638828"/>
            <a:ext cx="2332296" cy="1620000"/>
          </a:xfrm>
          <a:prstGeom prst="rect">
            <a:avLst/>
          </a:prstGeom>
        </p:spPr>
      </p:pic>
      <p:pic>
        <p:nvPicPr>
          <p:cNvPr id="6" name="図 5" descr="白黒の写真&#10;&#10;中程度の精度で自動的に生成された説明">
            <a:extLst>
              <a:ext uri="{FF2B5EF4-FFF2-40B4-BE49-F238E27FC236}">
                <a16:creationId xmlns:a16="http://schemas.microsoft.com/office/drawing/2014/main" id="{95A0D2AF-FF88-99F9-A1C9-7551FBCB681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6707"/>
          <a:stretch/>
        </p:blipFill>
        <p:spPr>
          <a:xfrm>
            <a:off x="2978595" y="637126"/>
            <a:ext cx="2332296" cy="163189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51A4B466-F4C1-414F-B5D7-8C027CB6AA9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19169" y="1238566"/>
            <a:ext cx="3058450" cy="231838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7D2B50E-FCB1-45BE-9D61-1047B0E0849C}"/>
              </a:ext>
            </a:extLst>
          </p:cNvPr>
          <p:cNvSpPr txBox="1"/>
          <p:nvPr/>
        </p:nvSpPr>
        <p:spPr>
          <a:xfrm>
            <a:off x="10091365" y="1527484"/>
            <a:ext cx="1571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R</a:t>
            </a:r>
            <a:r>
              <a:rPr kumimoji="1" lang="en-US" altLang="ja-JP" baseline="30000" dirty="0"/>
              <a:t>2</a:t>
            </a:r>
            <a:r>
              <a:rPr kumimoji="1" lang="en-US" altLang="ja-JP" dirty="0"/>
              <a:t>=0.8324</a:t>
            </a:r>
            <a:endParaRPr kumimoji="1" lang="ja-JP" altLang="en-US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058D2A3B-C58F-4B7C-8D2C-7A824CDCDA2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3064" y="4207619"/>
            <a:ext cx="3028188" cy="245211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F7370F1-4344-4AAD-A0E8-5F2B0FDE611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6243" y="4186126"/>
            <a:ext cx="2953512" cy="254355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ADBB319B-F398-4948-AF61-BE76A09D65F8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9907" y="4265336"/>
            <a:ext cx="2939796" cy="2878836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C606DAD-BC27-44AB-9097-15E14528F924}"/>
              </a:ext>
            </a:extLst>
          </p:cNvPr>
          <p:cNvSpPr txBox="1"/>
          <p:nvPr/>
        </p:nvSpPr>
        <p:spPr>
          <a:xfrm>
            <a:off x="2059902" y="1695714"/>
            <a:ext cx="753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E2ABABA-7963-4250-9886-7B8DB9AA4C9A}"/>
              </a:ext>
            </a:extLst>
          </p:cNvPr>
          <p:cNvSpPr txBox="1"/>
          <p:nvPr/>
        </p:nvSpPr>
        <p:spPr>
          <a:xfrm>
            <a:off x="616102" y="185338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1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BB65AA6-505C-449D-9E1B-47CECB265500}"/>
              </a:ext>
            </a:extLst>
          </p:cNvPr>
          <p:cNvSpPr txBox="1"/>
          <p:nvPr/>
        </p:nvSpPr>
        <p:spPr>
          <a:xfrm>
            <a:off x="8646983" y="450730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2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445AD83-24C5-4BCD-8BC0-56EB9E31203E}"/>
              </a:ext>
            </a:extLst>
          </p:cNvPr>
          <p:cNvSpPr txBox="1"/>
          <p:nvPr/>
        </p:nvSpPr>
        <p:spPr>
          <a:xfrm>
            <a:off x="859656" y="4038751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3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81DDFA1-AC6D-4A22-80EB-2F6C8358DFA7}"/>
              </a:ext>
            </a:extLst>
          </p:cNvPr>
          <p:cNvSpPr txBox="1"/>
          <p:nvPr/>
        </p:nvSpPr>
        <p:spPr>
          <a:xfrm>
            <a:off x="4484305" y="4069992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4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7361240-7353-40F9-AACD-65F7AD16114A}"/>
              </a:ext>
            </a:extLst>
          </p:cNvPr>
          <p:cNvSpPr txBox="1"/>
          <p:nvPr/>
        </p:nvSpPr>
        <p:spPr>
          <a:xfrm>
            <a:off x="8271288" y="4038751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5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8417A03-6383-44FB-A51C-39828929EE84}"/>
              </a:ext>
            </a:extLst>
          </p:cNvPr>
          <p:cNvSpPr txBox="1"/>
          <p:nvPr/>
        </p:nvSpPr>
        <p:spPr>
          <a:xfrm>
            <a:off x="610024" y="659969"/>
            <a:ext cx="1549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EEK (SBF 7 d)</a:t>
            </a:r>
            <a:endParaRPr kumimoji="1" lang="ja-JP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33A4F5F-63D5-4403-8712-83215BC0CD0D}"/>
              </a:ext>
            </a:extLst>
          </p:cNvPr>
          <p:cNvSpPr txBox="1"/>
          <p:nvPr/>
        </p:nvSpPr>
        <p:spPr>
          <a:xfrm>
            <a:off x="2970917" y="642316"/>
            <a:ext cx="23320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fonated CPEEK (SBF 7 d)</a:t>
            </a:r>
            <a:endParaRPr kumimoji="1" lang="ja-JP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304D0BD-D0E2-42EE-BC9C-1660C8C9EAF5}"/>
              </a:ext>
            </a:extLst>
          </p:cNvPr>
          <p:cNvSpPr txBox="1"/>
          <p:nvPr/>
        </p:nvSpPr>
        <p:spPr>
          <a:xfrm>
            <a:off x="610024" y="2336696"/>
            <a:ext cx="2310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fonated CPEEK following glow discharge (SBF 7 d)</a:t>
            </a:r>
            <a:endParaRPr kumimoji="1" lang="ja-JP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38EBD1D-7AAC-4A72-BE07-CDA2D7BE9D6F}"/>
              </a:ext>
            </a:extLst>
          </p:cNvPr>
          <p:cNvSpPr txBox="1"/>
          <p:nvPr/>
        </p:nvSpPr>
        <p:spPr>
          <a:xfrm>
            <a:off x="3004286" y="2344367"/>
            <a:ext cx="1830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EEK-AN (SBF 1 d)</a:t>
            </a:r>
            <a:endParaRPr kumimoji="1" lang="ja-JP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960367F-B9A7-444A-8CF9-9A7CE2E40EBF}"/>
              </a:ext>
            </a:extLst>
          </p:cNvPr>
          <p:cNvSpPr txBox="1"/>
          <p:nvPr/>
        </p:nvSpPr>
        <p:spPr>
          <a:xfrm>
            <a:off x="1081769" y="198171"/>
            <a:ext cx="4271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u="sng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600" u="sng" dirty="0">
                <a:latin typeface="Arial" panose="020B0604020202020204" pitchFamily="34" charset="0"/>
                <a:cs typeface="Arial" panose="020B0604020202020204" pitchFamily="34" charset="0"/>
              </a:rPr>
              <a:t>fter apatite-forming ability test in SBF</a:t>
            </a:r>
            <a:endParaRPr kumimoji="1" lang="ja-JP" altLang="en-US" sz="16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C1DDE4F-78BF-485E-8FC7-C639F8691B02}"/>
              </a:ext>
            </a:extLst>
          </p:cNvPr>
          <p:cNvSpPr txBox="1"/>
          <p:nvPr/>
        </p:nvSpPr>
        <p:spPr>
          <a:xfrm>
            <a:off x="9225412" y="525423"/>
            <a:ext cx="24375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relationship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etween bone surface / bone volume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rabecular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icknes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16FAB0C8-70AA-82D4-4062-F84CC60FAA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0544753"/>
              </p:ext>
            </p:extLst>
          </p:nvPr>
        </p:nvGraphicFramePr>
        <p:xfrm>
          <a:off x="5160601" y="1739646"/>
          <a:ext cx="3443189" cy="26077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ｸﾞﾗﾌ" r:id="rId14" imgW="4296960" imgH="3254400" progId="Origin50.Graph">
                  <p:embed/>
                </p:oleObj>
              </mc:Choice>
              <mc:Fallback>
                <p:oleObj name="ｸﾞﾗﾌ" r:id="rId14" imgW="4296960" imgH="3254400" progId="Origin50.Graph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16FAB0C8-70AA-82D4-4062-F84CC60FAA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160601" y="1739646"/>
                        <a:ext cx="3443189" cy="26077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1F24444E-F87C-58FF-0316-C8B0515EEF3E}"/>
              </a:ext>
            </a:extLst>
          </p:cNvPr>
          <p:cNvCxnSpPr>
            <a:cxnSpLocks/>
          </p:cNvCxnSpPr>
          <p:nvPr/>
        </p:nvCxnSpPr>
        <p:spPr>
          <a:xfrm flipV="1">
            <a:off x="4654966" y="2397756"/>
            <a:ext cx="1798386" cy="92222"/>
          </a:xfrm>
          <a:prstGeom prst="straightConnector1">
            <a:avLst/>
          </a:prstGeom>
          <a:ln w="3810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CFA678B4-AFDC-3FC3-FA4B-AAC8B4254734}"/>
              </a:ext>
            </a:extLst>
          </p:cNvPr>
          <p:cNvSpPr/>
          <p:nvPr/>
        </p:nvSpPr>
        <p:spPr>
          <a:xfrm>
            <a:off x="4309755" y="3792435"/>
            <a:ext cx="917322" cy="96132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DF5D142E-BE98-F605-E604-41B9FEB721BE}"/>
              </a:ext>
            </a:extLst>
          </p:cNvPr>
          <p:cNvSpPr/>
          <p:nvPr/>
        </p:nvSpPr>
        <p:spPr>
          <a:xfrm>
            <a:off x="1949670" y="2094484"/>
            <a:ext cx="917322" cy="96132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3D23132-26A3-97F8-0496-C64504A2081B}"/>
              </a:ext>
            </a:extLst>
          </p:cNvPr>
          <p:cNvSpPr txBox="1"/>
          <p:nvPr/>
        </p:nvSpPr>
        <p:spPr>
          <a:xfrm>
            <a:off x="4421051" y="3407832"/>
            <a:ext cx="753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1974273-00D9-014A-8BA1-D14547B4B4D1}"/>
              </a:ext>
            </a:extLst>
          </p:cNvPr>
          <p:cNvSpPr txBox="1"/>
          <p:nvPr/>
        </p:nvSpPr>
        <p:spPr>
          <a:xfrm>
            <a:off x="4397582" y="1693826"/>
            <a:ext cx="753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25BA92D2-0E0C-8C18-D01F-FAD45E53CD05}"/>
              </a:ext>
            </a:extLst>
          </p:cNvPr>
          <p:cNvSpPr/>
          <p:nvPr/>
        </p:nvSpPr>
        <p:spPr>
          <a:xfrm>
            <a:off x="4287350" y="2092596"/>
            <a:ext cx="917322" cy="96132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0D956E6-75DF-2D6C-67CB-2DC21AA2B348}"/>
              </a:ext>
            </a:extLst>
          </p:cNvPr>
          <p:cNvSpPr txBox="1"/>
          <p:nvPr/>
        </p:nvSpPr>
        <p:spPr>
          <a:xfrm>
            <a:off x="2058080" y="3396342"/>
            <a:ext cx="753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ED9934D0-AE42-7094-3B35-F0537786332C}"/>
              </a:ext>
            </a:extLst>
          </p:cNvPr>
          <p:cNvSpPr/>
          <p:nvPr/>
        </p:nvSpPr>
        <p:spPr>
          <a:xfrm>
            <a:off x="1947848" y="3795112"/>
            <a:ext cx="917322" cy="96132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858461F0-9F44-12C8-593D-60BBB3FE2521}"/>
              </a:ext>
            </a:extLst>
          </p:cNvPr>
          <p:cNvSpPr/>
          <p:nvPr/>
        </p:nvSpPr>
        <p:spPr>
          <a:xfrm>
            <a:off x="7978878" y="2937929"/>
            <a:ext cx="500902" cy="8545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33A064F-5AB1-0414-BE07-D952C8FD2851}"/>
              </a:ext>
            </a:extLst>
          </p:cNvPr>
          <p:cNvSpPr txBox="1"/>
          <p:nvPr/>
        </p:nvSpPr>
        <p:spPr>
          <a:xfrm>
            <a:off x="7891252" y="3024583"/>
            <a:ext cx="9911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BF 1 d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A2E3859-C97D-6D27-9641-F7FC3190C7F4}"/>
              </a:ext>
            </a:extLst>
          </p:cNvPr>
          <p:cNvSpPr txBox="1"/>
          <p:nvPr/>
        </p:nvSpPr>
        <p:spPr>
          <a:xfrm>
            <a:off x="7891252" y="3509987"/>
            <a:ext cx="9911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BF 0 d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F4BD832-F026-499D-33FC-1BF75B89FA7B}"/>
              </a:ext>
            </a:extLst>
          </p:cNvPr>
          <p:cNvSpPr txBox="1"/>
          <p:nvPr/>
        </p:nvSpPr>
        <p:spPr>
          <a:xfrm>
            <a:off x="5426270" y="1724603"/>
            <a:ext cx="27477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nges in EDX on CPEEK-AN</a:t>
            </a:r>
          </a:p>
        </p:txBody>
      </p:sp>
    </p:spTree>
    <p:extLst>
      <p:ext uri="{BB962C8B-B14F-4D97-AF65-F5344CB8AC3E}">
        <p14:creationId xmlns:p14="http://schemas.microsoft.com/office/powerpoint/2010/main" val="8844400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CE98AA57-CAD4-4169-84D7-13EB4659D2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8574" y="2327281"/>
            <a:ext cx="2259793" cy="1694845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51A4B466-F4C1-414F-B5D7-8C027CB6AA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19169" y="1238566"/>
            <a:ext cx="3058450" cy="231838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7D2B50E-FCB1-45BE-9D61-1047B0E0849C}"/>
              </a:ext>
            </a:extLst>
          </p:cNvPr>
          <p:cNvSpPr txBox="1"/>
          <p:nvPr/>
        </p:nvSpPr>
        <p:spPr>
          <a:xfrm>
            <a:off x="10091365" y="1527484"/>
            <a:ext cx="1571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R</a:t>
            </a:r>
            <a:r>
              <a:rPr kumimoji="1" lang="en-US" altLang="ja-JP" baseline="30000" dirty="0"/>
              <a:t>2</a:t>
            </a:r>
            <a:r>
              <a:rPr kumimoji="1" lang="en-US" altLang="ja-JP" dirty="0"/>
              <a:t>=0.8324</a:t>
            </a:r>
            <a:endParaRPr kumimoji="1" lang="ja-JP" altLang="en-US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058D2A3B-C58F-4B7C-8D2C-7A824CDCDA2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3064" y="4207619"/>
            <a:ext cx="3028188" cy="245211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F7370F1-4344-4AAD-A0E8-5F2B0FDE61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6243" y="4186126"/>
            <a:ext cx="2953512" cy="254355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ADBB319B-F398-4948-AF61-BE76A09D65F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9907" y="4265336"/>
            <a:ext cx="2939796" cy="2878836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FC275ECC-92A0-4371-9FCD-BE35A80208A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335" b="6790"/>
          <a:stretch/>
        </p:blipFill>
        <p:spPr>
          <a:xfrm>
            <a:off x="569705" y="2317315"/>
            <a:ext cx="2259793" cy="1704811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3764490D-5C3A-44FD-9D41-0608351BB4F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795" y="632437"/>
            <a:ext cx="2259793" cy="1694845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69C4EBB6-3771-498D-9A9C-4D114EB9252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1895" y="632436"/>
            <a:ext cx="2259793" cy="1694845"/>
          </a:xfrm>
          <a:prstGeom prst="rect">
            <a:avLst/>
          </a:prstGeom>
        </p:spPr>
      </p:pic>
      <p:sp>
        <p:nvSpPr>
          <p:cNvPr id="19" name="テキスト ボックス 2">
            <a:extLst>
              <a:ext uri="{FF2B5EF4-FFF2-40B4-BE49-F238E27FC236}">
                <a16:creationId xmlns:a16="http://schemas.microsoft.com/office/drawing/2014/main" id="{148D5E3C-0806-4D03-BFD1-F194BD830B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9351" y="4066932"/>
            <a:ext cx="1187115" cy="3129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ts val="1300"/>
              </a:lnSpc>
              <a:spcAft>
                <a:spcPts val="0"/>
              </a:spcAft>
            </a:pPr>
            <a:r>
              <a:rPr lang="en-US" sz="2800" dirty="0">
                <a:solidFill>
                  <a:srgbClr val="FFFFFF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 </a:t>
            </a:r>
            <a:r>
              <a:rPr lang="en-US" sz="2800" dirty="0">
                <a:solidFill>
                  <a:srgbClr val="FFFFFF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µm</a:t>
            </a:r>
            <a:endParaRPr lang="ja-JP" sz="2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6E585E71-552A-4D75-8DFF-20245C21778D}"/>
              </a:ext>
            </a:extLst>
          </p:cNvPr>
          <p:cNvSpPr/>
          <p:nvPr/>
        </p:nvSpPr>
        <p:spPr>
          <a:xfrm>
            <a:off x="718881" y="2164944"/>
            <a:ext cx="840395" cy="70937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C606DAD-BC27-44AB-9097-15E14528F924}"/>
              </a:ext>
            </a:extLst>
          </p:cNvPr>
          <p:cNvSpPr txBox="1"/>
          <p:nvPr/>
        </p:nvSpPr>
        <p:spPr>
          <a:xfrm>
            <a:off x="751091" y="1821284"/>
            <a:ext cx="753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µm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E2ABABA-7963-4250-9886-7B8DB9AA4C9A}"/>
              </a:ext>
            </a:extLst>
          </p:cNvPr>
          <p:cNvSpPr txBox="1"/>
          <p:nvPr/>
        </p:nvSpPr>
        <p:spPr>
          <a:xfrm>
            <a:off x="384264" y="183912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1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BB65AA6-505C-449D-9E1B-47CECB265500}"/>
              </a:ext>
            </a:extLst>
          </p:cNvPr>
          <p:cNvSpPr txBox="1"/>
          <p:nvPr/>
        </p:nvSpPr>
        <p:spPr>
          <a:xfrm>
            <a:off x="8646983" y="450730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2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445AD83-24C5-4BCD-8BC0-56EB9E31203E}"/>
              </a:ext>
            </a:extLst>
          </p:cNvPr>
          <p:cNvSpPr txBox="1"/>
          <p:nvPr/>
        </p:nvSpPr>
        <p:spPr>
          <a:xfrm>
            <a:off x="859656" y="4038751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3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81DDFA1-AC6D-4A22-80EB-2F6C8358DFA7}"/>
              </a:ext>
            </a:extLst>
          </p:cNvPr>
          <p:cNvSpPr txBox="1"/>
          <p:nvPr/>
        </p:nvSpPr>
        <p:spPr>
          <a:xfrm>
            <a:off x="4484305" y="4069992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4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7361240-7353-40F9-AACD-65F7AD16114A}"/>
              </a:ext>
            </a:extLst>
          </p:cNvPr>
          <p:cNvSpPr txBox="1"/>
          <p:nvPr/>
        </p:nvSpPr>
        <p:spPr>
          <a:xfrm>
            <a:off x="8271288" y="4038751"/>
            <a:ext cx="46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5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8417A03-6383-44FB-A51C-39828929EE84}"/>
              </a:ext>
            </a:extLst>
          </p:cNvPr>
          <p:cNvSpPr txBox="1"/>
          <p:nvPr/>
        </p:nvSpPr>
        <p:spPr>
          <a:xfrm>
            <a:off x="577795" y="666151"/>
            <a:ext cx="824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EEK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33A4F5F-63D5-4403-8712-83215BC0CD0D}"/>
              </a:ext>
            </a:extLst>
          </p:cNvPr>
          <p:cNvSpPr txBox="1"/>
          <p:nvPr/>
        </p:nvSpPr>
        <p:spPr>
          <a:xfrm>
            <a:off x="3057013" y="735457"/>
            <a:ext cx="14349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fonated CPEEK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304D0BD-D0E2-42EE-BC9C-1660C8C9EAF5}"/>
              </a:ext>
            </a:extLst>
          </p:cNvPr>
          <p:cNvSpPr txBox="1"/>
          <p:nvPr/>
        </p:nvSpPr>
        <p:spPr>
          <a:xfrm>
            <a:off x="577795" y="2368237"/>
            <a:ext cx="27532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fonated CPEEK </a:t>
            </a:r>
          </a:p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ing glow discharge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38EBD1D-7AAC-4A72-BE07-CDA2D7BE9D6F}"/>
              </a:ext>
            </a:extLst>
          </p:cNvPr>
          <p:cNvSpPr txBox="1"/>
          <p:nvPr/>
        </p:nvSpPr>
        <p:spPr>
          <a:xfrm>
            <a:off x="2866992" y="2435561"/>
            <a:ext cx="1070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EEK-AN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960367F-B9A7-444A-8CF9-9A7CE2E40EBF}"/>
              </a:ext>
            </a:extLst>
          </p:cNvPr>
          <p:cNvSpPr txBox="1"/>
          <p:nvPr/>
        </p:nvSpPr>
        <p:spPr>
          <a:xfrm>
            <a:off x="836523" y="247157"/>
            <a:ext cx="3101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patite-forming ability tes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C1DDE4F-78BF-485E-8FC7-C639F8691B02}"/>
              </a:ext>
            </a:extLst>
          </p:cNvPr>
          <p:cNvSpPr txBox="1"/>
          <p:nvPr/>
        </p:nvSpPr>
        <p:spPr>
          <a:xfrm>
            <a:off x="9225412" y="525423"/>
            <a:ext cx="24375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relationship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etween bone surface / bone volume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rabecular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icknes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16FAB0C8-70AA-82D4-4062-F84CC60FAA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4352444"/>
              </p:ext>
            </p:extLst>
          </p:nvPr>
        </p:nvGraphicFramePr>
        <p:xfrm>
          <a:off x="4906454" y="1999190"/>
          <a:ext cx="3443189" cy="26077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ｸﾞﾗﾌ" r:id="rId11" imgW="4296960" imgH="3254400" progId="Origin50.Graph">
                  <p:embed/>
                </p:oleObj>
              </mc:Choice>
              <mc:Fallback>
                <p:oleObj name="ｸﾞﾗﾌ" r:id="rId11" imgW="4296960" imgH="3254400" progId="Origin50.Graph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16FAB0C8-70AA-82D4-4062-F84CC60FAA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906454" y="1999190"/>
                        <a:ext cx="3443189" cy="26077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1F24444E-F87C-58FF-0316-C8B0515EEF3E}"/>
              </a:ext>
            </a:extLst>
          </p:cNvPr>
          <p:cNvCxnSpPr>
            <a:cxnSpLocks/>
          </p:cNvCxnSpPr>
          <p:nvPr/>
        </p:nvCxnSpPr>
        <p:spPr>
          <a:xfrm>
            <a:off x="3843041" y="2574060"/>
            <a:ext cx="1441034" cy="0"/>
          </a:xfrm>
          <a:prstGeom prst="straightConnector1">
            <a:avLst/>
          </a:prstGeom>
          <a:ln w="3810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357020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4</TotalTime>
  <Words>124</Words>
  <Application>Microsoft Office PowerPoint</Application>
  <PresentationFormat>ワイド画面</PresentationFormat>
  <Paragraphs>36</Paragraphs>
  <Slides>2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Palatino Linotype</vt:lpstr>
      <vt:lpstr>Office テーマ</vt:lpstr>
      <vt:lpstr>ｸﾞﾗﾌ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岡 佑輔</dc:creator>
  <cp:lastModifiedBy>高岡 佑輔</cp:lastModifiedBy>
  <cp:revision>14</cp:revision>
  <dcterms:created xsi:type="dcterms:W3CDTF">2022-02-23T04:37:44Z</dcterms:created>
  <dcterms:modified xsi:type="dcterms:W3CDTF">2023-01-04T03:06:40Z</dcterms:modified>
</cp:coreProperties>
</file>